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5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436" autoAdjust="0"/>
    <p:restoredTop sz="94620" autoAdjust="0"/>
  </p:normalViewPr>
  <p:slideViewPr>
    <p:cSldViewPr snapToGrid="0">
      <p:cViewPr>
        <p:scale>
          <a:sx n="130" d="100"/>
          <a:sy n="130" d="100"/>
        </p:scale>
        <p:origin x="234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00CCCD-0DE2-41EA-99A5-A1DA61A6128D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FEC2C9-52E5-40B7-B4E3-18E24763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680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022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40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896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470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180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2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52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29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642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242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068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503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Text Box 6">
            <a:extLst>
              <a:ext uri="{FF2B5EF4-FFF2-40B4-BE49-F238E27FC236}">
                <a16:creationId xmlns:a16="http://schemas.microsoft.com/office/drawing/2014/main" id="{7B865B4F-65A3-4F35-AB51-A592A279F5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5326" y="195511"/>
            <a:ext cx="7620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1200" dirty="0">
                <a:latin typeface="Arial" pitchFamily="34" charset="0"/>
                <a:cs typeface="Arial" pitchFamily="34" charset="0"/>
              </a:rPr>
              <a:t>Fig S11</a:t>
            </a:r>
            <a:endParaRPr lang="en-US" sz="12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8EE854E-73AF-4661-A8CB-B57BB2066DEC}"/>
              </a:ext>
            </a:extLst>
          </p:cNvPr>
          <p:cNvSpPr txBox="1"/>
          <p:nvPr/>
        </p:nvSpPr>
        <p:spPr>
          <a:xfrm>
            <a:off x="179549" y="2355513"/>
            <a:ext cx="637599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1: Schematic diagram of the rearranged molecular network upon rival oncogene expression in melanoma cell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 suppressive melanoma cells a RTK inhibitor (SPRY4) is upregulated, which in turn activate tumor suppressor pathway, that finally results in cellular growth arrest and senescence (  ). In non-suppressive cells, SPRY4 is inhibited by second oncogene that results in cellular growth and drug resistance (  ). The common event between suppressive and non-suppressive signaling is the activation of MAP kinases and antagonizing each others function. </a:t>
            </a:r>
            <a:endParaRPr lang="en-US" sz="1100" baseline="30000" dirty="0">
              <a:solidFill>
                <a:srgbClr val="0046D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D79544A-52C4-41E6-8490-FBAB32F8D978}"/>
              </a:ext>
            </a:extLst>
          </p:cNvPr>
          <p:cNvSpPr txBox="1"/>
          <p:nvPr/>
        </p:nvSpPr>
        <p:spPr>
          <a:xfrm>
            <a:off x="2143793" y="258317"/>
            <a:ext cx="9428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ressive</a:t>
            </a:r>
            <a:endParaRPr lang="en-US" sz="1000" b="1" baseline="30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4C05FBA-0211-4B8F-99D2-54B13CFED3E3}"/>
              </a:ext>
            </a:extLst>
          </p:cNvPr>
          <p:cNvSpPr txBox="1"/>
          <p:nvPr/>
        </p:nvSpPr>
        <p:spPr>
          <a:xfrm>
            <a:off x="3033848" y="256319"/>
            <a:ext cx="1143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-suppressive</a:t>
            </a:r>
            <a:endParaRPr lang="en-US" sz="1000" b="1" baseline="30000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35410E2-A0F1-4706-8BD0-281333C5D9D8}"/>
              </a:ext>
            </a:extLst>
          </p:cNvPr>
          <p:cNvSpPr txBox="1"/>
          <p:nvPr/>
        </p:nvSpPr>
        <p:spPr>
          <a:xfrm>
            <a:off x="2835084" y="889143"/>
            <a:ext cx="564293" cy="271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13" dirty="0"/>
              <a:t>SPRY4 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019C91EA-BD8D-4DC2-B2BF-7DD3C6F770EF}"/>
              </a:ext>
            </a:extLst>
          </p:cNvPr>
          <p:cNvSpPr txBox="1"/>
          <p:nvPr/>
        </p:nvSpPr>
        <p:spPr>
          <a:xfrm>
            <a:off x="3123606" y="1222666"/>
            <a:ext cx="53850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>
                <a:solidFill>
                  <a:schemeClr val="accent5">
                    <a:lumMod val="75000"/>
                  </a:schemeClr>
                </a:solidFill>
              </a:rPr>
              <a:t>NRAS*</a:t>
            </a:r>
            <a:endParaRPr lang="en-US" sz="1013" baseline="30000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9D6AEA7-5EA2-4761-B65A-28CBDA2A3AF0}"/>
              </a:ext>
            </a:extLst>
          </p:cNvPr>
          <p:cNvSpPr txBox="1"/>
          <p:nvPr/>
        </p:nvSpPr>
        <p:spPr>
          <a:xfrm>
            <a:off x="2564257" y="1222666"/>
            <a:ext cx="52565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>
                <a:solidFill>
                  <a:srgbClr val="FF0000"/>
                </a:solidFill>
              </a:rPr>
              <a:t>BRAF*</a:t>
            </a:r>
            <a:endParaRPr lang="en-US" sz="1013" baseline="30000" dirty="0">
              <a:solidFill>
                <a:srgbClr val="FF0000"/>
              </a:solidFill>
            </a:endParaRP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53DB91FA-1E9A-4D7A-AF03-3BFDE82005E8}"/>
              </a:ext>
            </a:extLst>
          </p:cNvPr>
          <p:cNvCxnSpPr/>
          <p:nvPr/>
        </p:nvCxnSpPr>
        <p:spPr>
          <a:xfrm flipV="1">
            <a:off x="2855403" y="1113578"/>
            <a:ext cx="120933" cy="149657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5" name="Group 54">
            <a:extLst>
              <a:ext uri="{FF2B5EF4-FFF2-40B4-BE49-F238E27FC236}">
                <a16:creationId xmlns:a16="http://schemas.microsoft.com/office/drawing/2014/main" id="{A6233744-8422-404D-99E0-4D257C585DAB}"/>
              </a:ext>
            </a:extLst>
          </p:cNvPr>
          <p:cNvGrpSpPr/>
          <p:nvPr/>
        </p:nvGrpSpPr>
        <p:grpSpPr>
          <a:xfrm>
            <a:off x="3037949" y="1306922"/>
            <a:ext cx="138229" cy="80747"/>
            <a:chOff x="3431242" y="3662255"/>
            <a:chExt cx="597052" cy="153638"/>
          </a:xfrm>
        </p:grpSpPr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B13FAE11-BD92-4F56-AFC2-39A141BFB2A2}"/>
                </a:ext>
              </a:extLst>
            </p:cNvPr>
            <p:cNvCxnSpPr/>
            <p:nvPr/>
          </p:nvCxnSpPr>
          <p:spPr>
            <a:xfrm flipV="1">
              <a:off x="3431242" y="3733801"/>
              <a:ext cx="597052" cy="5274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15256544-FBC5-408F-A972-BE1614A3D29B}"/>
                </a:ext>
              </a:extLst>
            </p:cNvPr>
            <p:cNvCxnSpPr/>
            <p:nvPr/>
          </p:nvCxnSpPr>
          <p:spPr>
            <a:xfrm>
              <a:off x="4028294" y="3662255"/>
              <a:ext cx="0" cy="15363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BD87AA28-37FB-482D-9ABA-B1382C85A4DA}"/>
                </a:ext>
              </a:extLst>
            </p:cNvPr>
            <p:cNvCxnSpPr/>
            <p:nvPr/>
          </p:nvCxnSpPr>
          <p:spPr>
            <a:xfrm>
              <a:off x="3431242" y="3662255"/>
              <a:ext cx="0" cy="15363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8012B241-1CDB-4495-B4D4-A9C57AAB84AC}"/>
              </a:ext>
            </a:extLst>
          </p:cNvPr>
          <p:cNvCxnSpPr>
            <a:cxnSpLocks/>
          </p:cNvCxnSpPr>
          <p:nvPr/>
        </p:nvCxnSpPr>
        <p:spPr>
          <a:xfrm flipH="1">
            <a:off x="3250542" y="1442754"/>
            <a:ext cx="102382" cy="141092"/>
          </a:xfrm>
          <a:prstGeom prst="straightConnector1">
            <a:avLst/>
          </a:prstGeom>
          <a:ln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A35D1A74-23D7-4208-AD8A-BCDF2F9CDD22}"/>
              </a:ext>
            </a:extLst>
          </p:cNvPr>
          <p:cNvSpPr txBox="1"/>
          <p:nvPr/>
        </p:nvSpPr>
        <p:spPr>
          <a:xfrm>
            <a:off x="2856465" y="1558457"/>
            <a:ext cx="529046" cy="271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MAPK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2B1EBF8-778D-4C02-B2CF-D272C406F0FE}"/>
              </a:ext>
            </a:extLst>
          </p:cNvPr>
          <p:cNvSpPr txBox="1"/>
          <p:nvPr/>
        </p:nvSpPr>
        <p:spPr>
          <a:xfrm>
            <a:off x="2143589" y="1815548"/>
            <a:ext cx="836202" cy="271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Senescence</a:t>
            </a:r>
          </a:p>
        </p:txBody>
      </p: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09E74DCD-88D4-47D7-81B2-743353CD4A28}"/>
              </a:ext>
            </a:extLst>
          </p:cNvPr>
          <p:cNvCxnSpPr/>
          <p:nvPr/>
        </p:nvCxnSpPr>
        <p:spPr>
          <a:xfrm flipV="1">
            <a:off x="2168090" y="1840211"/>
            <a:ext cx="0" cy="140638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36B548E6-9703-456C-AFF8-2B16E23D7576}"/>
              </a:ext>
            </a:extLst>
          </p:cNvPr>
          <p:cNvCxnSpPr/>
          <p:nvPr/>
        </p:nvCxnSpPr>
        <p:spPr>
          <a:xfrm>
            <a:off x="2174736" y="1694636"/>
            <a:ext cx="0" cy="140638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EFFBB166-DE73-4465-AF93-B1E734130D50}"/>
              </a:ext>
            </a:extLst>
          </p:cNvPr>
          <p:cNvSpPr txBox="1"/>
          <p:nvPr/>
        </p:nvSpPr>
        <p:spPr>
          <a:xfrm>
            <a:off x="2145258" y="1668185"/>
            <a:ext cx="612968" cy="271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Growth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83A98680-32BC-4360-BE1F-AD2C772D69C8}"/>
              </a:ext>
            </a:extLst>
          </p:cNvPr>
          <p:cNvSpPr txBox="1"/>
          <p:nvPr/>
        </p:nvSpPr>
        <p:spPr>
          <a:xfrm>
            <a:off x="3454524" y="1815108"/>
            <a:ext cx="550151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 err="1"/>
              <a:t>Vem</a:t>
            </a:r>
            <a:r>
              <a:rPr lang="en-US" sz="1013" baseline="30000" dirty="0" err="1"/>
              <a:t>Res</a:t>
            </a:r>
            <a:endParaRPr lang="en-US" sz="1013" baseline="30000" dirty="0"/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9E9DDB9B-BA9D-4C63-9522-0B5923C36A8C}"/>
              </a:ext>
            </a:extLst>
          </p:cNvPr>
          <p:cNvCxnSpPr>
            <a:cxnSpLocks/>
          </p:cNvCxnSpPr>
          <p:nvPr/>
        </p:nvCxnSpPr>
        <p:spPr>
          <a:xfrm flipH="1" flipV="1">
            <a:off x="3247351" y="1124748"/>
            <a:ext cx="116939" cy="138488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F68E85AC-6405-4359-8EB0-2F0616A2C913}"/>
              </a:ext>
            </a:extLst>
          </p:cNvPr>
          <p:cNvCxnSpPr>
            <a:cxnSpLocks/>
          </p:cNvCxnSpPr>
          <p:nvPr/>
        </p:nvCxnSpPr>
        <p:spPr>
          <a:xfrm flipH="1">
            <a:off x="2415072" y="1348218"/>
            <a:ext cx="131791" cy="668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D07A26C8-4423-4155-9DFE-0C14741B9FE2}"/>
              </a:ext>
            </a:extLst>
          </p:cNvPr>
          <p:cNvSpPr txBox="1"/>
          <p:nvPr/>
        </p:nvSpPr>
        <p:spPr>
          <a:xfrm>
            <a:off x="2054902" y="1221128"/>
            <a:ext cx="38504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>
                <a:solidFill>
                  <a:srgbClr val="FF0000"/>
                </a:solidFill>
              </a:rPr>
              <a:t>p21</a:t>
            </a:r>
            <a:endParaRPr lang="en-US" sz="1013" baseline="30000" dirty="0">
              <a:solidFill>
                <a:srgbClr val="FF0000"/>
              </a:solidFill>
            </a:endParaRPr>
          </a:p>
        </p:txBody>
      </p: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C80BF294-555A-487B-9A29-47961D476F8D}"/>
              </a:ext>
            </a:extLst>
          </p:cNvPr>
          <p:cNvCxnSpPr>
            <a:cxnSpLocks/>
          </p:cNvCxnSpPr>
          <p:nvPr/>
        </p:nvCxnSpPr>
        <p:spPr>
          <a:xfrm flipV="1">
            <a:off x="3998636" y="1695291"/>
            <a:ext cx="0" cy="139569"/>
          </a:xfrm>
          <a:prstGeom prst="straightConnector1">
            <a:avLst/>
          </a:prstGeom>
          <a:ln>
            <a:solidFill>
              <a:schemeClr val="accent5">
                <a:lumMod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08274A3E-CD88-47DF-AE09-48FAB61A1987}"/>
              </a:ext>
            </a:extLst>
          </p:cNvPr>
          <p:cNvSpPr txBox="1"/>
          <p:nvPr/>
        </p:nvSpPr>
        <p:spPr>
          <a:xfrm>
            <a:off x="3439691" y="1670156"/>
            <a:ext cx="612968" cy="271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Growth</a:t>
            </a:r>
          </a:p>
        </p:txBody>
      </p: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D786F182-EA56-4CEB-A9D7-FE76247E4B29}"/>
              </a:ext>
            </a:extLst>
          </p:cNvPr>
          <p:cNvCxnSpPr>
            <a:cxnSpLocks/>
          </p:cNvCxnSpPr>
          <p:nvPr/>
        </p:nvCxnSpPr>
        <p:spPr>
          <a:xfrm>
            <a:off x="2866450" y="1431558"/>
            <a:ext cx="108673" cy="149113"/>
          </a:xfrm>
          <a:prstGeom prst="straightConnector1">
            <a:avLst/>
          </a:prstGeom>
          <a:ln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BF9B9E52-6F45-4124-A80B-8C4B558A0528}"/>
              </a:ext>
            </a:extLst>
          </p:cNvPr>
          <p:cNvCxnSpPr>
            <a:cxnSpLocks/>
          </p:cNvCxnSpPr>
          <p:nvPr/>
        </p:nvCxnSpPr>
        <p:spPr>
          <a:xfrm flipH="1">
            <a:off x="3219451" y="1101837"/>
            <a:ext cx="61433" cy="5386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Oval 80">
            <a:extLst>
              <a:ext uri="{FF2B5EF4-FFF2-40B4-BE49-F238E27FC236}">
                <a16:creationId xmlns:a16="http://schemas.microsoft.com/office/drawing/2014/main" id="{B695C443-9D64-4F96-A244-04E724B2F479}"/>
              </a:ext>
            </a:extLst>
          </p:cNvPr>
          <p:cNvSpPr/>
          <p:nvPr/>
        </p:nvSpPr>
        <p:spPr>
          <a:xfrm>
            <a:off x="2607998" y="488241"/>
            <a:ext cx="1795189" cy="1687647"/>
          </a:xfrm>
          <a:prstGeom prst="ellipse">
            <a:avLst/>
          </a:prstGeom>
          <a:noFill/>
          <a:ln>
            <a:solidFill>
              <a:srgbClr val="0046D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>
              <a:solidFill>
                <a:srgbClr val="0070C0"/>
              </a:solidFill>
            </a:endParaRPr>
          </a:p>
        </p:txBody>
      </p:sp>
      <p:sp>
        <p:nvSpPr>
          <p:cNvPr id="82" name="Oval 81">
            <a:extLst>
              <a:ext uri="{FF2B5EF4-FFF2-40B4-BE49-F238E27FC236}">
                <a16:creationId xmlns:a16="http://schemas.microsoft.com/office/drawing/2014/main" id="{2891B357-3473-4D8B-A50F-40E7E620D3CE}"/>
              </a:ext>
            </a:extLst>
          </p:cNvPr>
          <p:cNvSpPr/>
          <p:nvPr/>
        </p:nvSpPr>
        <p:spPr>
          <a:xfrm>
            <a:off x="1795432" y="490151"/>
            <a:ext cx="1795189" cy="1687647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83" name="Freeform: Shape 82">
            <a:extLst>
              <a:ext uri="{FF2B5EF4-FFF2-40B4-BE49-F238E27FC236}">
                <a16:creationId xmlns:a16="http://schemas.microsoft.com/office/drawing/2014/main" id="{022B2929-0F49-40C2-9F1E-4FA9CFE4FE00}"/>
              </a:ext>
            </a:extLst>
          </p:cNvPr>
          <p:cNvSpPr/>
          <p:nvPr/>
        </p:nvSpPr>
        <p:spPr>
          <a:xfrm>
            <a:off x="2610669" y="578109"/>
            <a:ext cx="491563" cy="1504950"/>
          </a:xfrm>
          <a:custGeom>
            <a:avLst/>
            <a:gdLst>
              <a:gd name="connsiteX0" fmla="*/ 490488 w 490488"/>
              <a:gd name="connsiteY0" fmla="*/ 0 h 1504950"/>
              <a:gd name="connsiteX1" fmla="*/ 369838 w 490488"/>
              <a:gd name="connsiteY1" fmla="*/ 69850 h 1504950"/>
              <a:gd name="connsiteX2" fmla="*/ 249188 w 490488"/>
              <a:gd name="connsiteY2" fmla="*/ 171450 h 1504950"/>
              <a:gd name="connsiteX3" fmla="*/ 160288 w 490488"/>
              <a:gd name="connsiteY3" fmla="*/ 266700 h 1504950"/>
              <a:gd name="connsiteX4" fmla="*/ 96788 w 490488"/>
              <a:gd name="connsiteY4" fmla="*/ 368300 h 1504950"/>
              <a:gd name="connsiteX5" fmla="*/ 33288 w 490488"/>
              <a:gd name="connsiteY5" fmla="*/ 508000 h 1504950"/>
              <a:gd name="connsiteX6" fmla="*/ 7888 w 490488"/>
              <a:gd name="connsiteY6" fmla="*/ 654050 h 1504950"/>
              <a:gd name="connsiteX7" fmla="*/ 1538 w 490488"/>
              <a:gd name="connsiteY7" fmla="*/ 800100 h 1504950"/>
              <a:gd name="connsiteX8" fmla="*/ 33288 w 490488"/>
              <a:gd name="connsiteY8" fmla="*/ 977900 h 1504950"/>
              <a:gd name="connsiteX9" fmla="*/ 77738 w 490488"/>
              <a:gd name="connsiteY9" fmla="*/ 1117600 h 1504950"/>
              <a:gd name="connsiteX10" fmla="*/ 185688 w 490488"/>
              <a:gd name="connsiteY10" fmla="*/ 1263650 h 1504950"/>
              <a:gd name="connsiteX11" fmla="*/ 268238 w 490488"/>
              <a:gd name="connsiteY11" fmla="*/ 1358900 h 1504950"/>
              <a:gd name="connsiteX12" fmla="*/ 369838 w 490488"/>
              <a:gd name="connsiteY12" fmla="*/ 1447800 h 1504950"/>
              <a:gd name="connsiteX13" fmla="*/ 477788 w 490488"/>
              <a:gd name="connsiteY13" fmla="*/ 1504950 h 15049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490488" h="1504950">
                <a:moveTo>
                  <a:pt x="490488" y="0"/>
                </a:moveTo>
                <a:cubicBezTo>
                  <a:pt x="450271" y="20637"/>
                  <a:pt x="410055" y="41275"/>
                  <a:pt x="369838" y="69850"/>
                </a:cubicBezTo>
                <a:cubicBezTo>
                  <a:pt x="329621" y="98425"/>
                  <a:pt x="284113" y="138642"/>
                  <a:pt x="249188" y="171450"/>
                </a:cubicBezTo>
                <a:cubicBezTo>
                  <a:pt x="214263" y="204258"/>
                  <a:pt x="185688" y="233892"/>
                  <a:pt x="160288" y="266700"/>
                </a:cubicBezTo>
                <a:cubicBezTo>
                  <a:pt x="134888" y="299508"/>
                  <a:pt x="117955" y="328083"/>
                  <a:pt x="96788" y="368300"/>
                </a:cubicBezTo>
                <a:cubicBezTo>
                  <a:pt x="75621" y="408517"/>
                  <a:pt x="48105" y="460375"/>
                  <a:pt x="33288" y="508000"/>
                </a:cubicBezTo>
                <a:cubicBezTo>
                  <a:pt x="18471" y="555625"/>
                  <a:pt x="13180" y="605367"/>
                  <a:pt x="7888" y="654050"/>
                </a:cubicBezTo>
                <a:cubicBezTo>
                  <a:pt x="2596" y="702733"/>
                  <a:pt x="-2695" y="746125"/>
                  <a:pt x="1538" y="800100"/>
                </a:cubicBezTo>
                <a:cubicBezTo>
                  <a:pt x="5771" y="854075"/>
                  <a:pt x="20588" y="924983"/>
                  <a:pt x="33288" y="977900"/>
                </a:cubicBezTo>
                <a:cubicBezTo>
                  <a:pt x="45988" y="1030817"/>
                  <a:pt x="52338" y="1069975"/>
                  <a:pt x="77738" y="1117600"/>
                </a:cubicBezTo>
                <a:cubicBezTo>
                  <a:pt x="103138" y="1165225"/>
                  <a:pt x="153938" y="1223433"/>
                  <a:pt x="185688" y="1263650"/>
                </a:cubicBezTo>
                <a:cubicBezTo>
                  <a:pt x="217438" y="1303867"/>
                  <a:pt x="237546" y="1328208"/>
                  <a:pt x="268238" y="1358900"/>
                </a:cubicBezTo>
                <a:cubicBezTo>
                  <a:pt x="298930" y="1389592"/>
                  <a:pt x="334913" y="1423458"/>
                  <a:pt x="369838" y="1447800"/>
                </a:cubicBezTo>
                <a:cubicBezTo>
                  <a:pt x="404763" y="1472142"/>
                  <a:pt x="441275" y="1488546"/>
                  <a:pt x="477788" y="1504950"/>
                </a:cubicBezTo>
              </a:path>
            </a:pathLst>
          </a:custGeom>
          <a:noFill/>
          <a:ln w="3810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Freeform: Shape 83">
            <a:extLst>
              <a:ext uri="{FF2B5EF4-FFF2-40B4-BE49-F238E27FC236}">
                <a16:creationId xmlns:a16="http://schemas.microsoft.com/office/drawing/2014/main" id="{D8550C88-4638-4A82-95C8-C98D9E255880}"/>
              </a:ext>
            </a:extLst>
          </p:cNvPr>
          <p:cNvSpPr/>
          <p:nvPr/>
        </p:nvSpPr>
        <p:spPr>
          <a:xfrm>
            <a:off x="2615757" y="584645"/>
            <a:ext cx="491563" cy="1504950"/>
          </a:xfrm>
          <a:custGeom>
            <a:avLst/>
            <a:gdLst>
              <a:gd name="connsiteX0" fmla="*/ 490488 w 490488"/>
              <a:gd name="connsiteY0" fmla="*/ 0 h 1504950"/>
              <a:gd name="connsiteX1" fmla="*/ 369838 w 490488"/>
              <a:gd name="connsiteY1" fmla="*/ 69850 h 1504950"/>
              <a:gd name="connsiteX2" fmla="*/ 249188 w 490488"/>
              <a:gd name="connsiteY2" fmla="*/ 171450 h 1504950"/>
              <a:gd name="connsiteX3" fmla="*/ 160288 w 490488"/>
              <a:gd name="connsiteY3" fmla="*/ 266700 h 1504950"/>
              <a:gd name="connsiteX4" fmla="*/ 96788 w 490488"/>
              <a:gd name="connsiteY4" fmla="*/ 368300 h 1504950"/>
              <a:gd name="connsiteX5" fmla="*/ 33288 w 490488"/>
              <a:gd name="connsiteY5" fmla="*/ 508000 h 1504950"/>
              <a:gd name="connsiteX6" fmla="*/ 7888 w 490488"/>
              <a:gd name="connsiteY6" fmla="*/ 654050 h 1504950"/>
              <a:gd name="connsiteX7" fmla="*/ 1538 w 490488"/>
              <a:gd name="connsiteY7" fmla="*/ 800100 h 1504950"/>
              <a:gd name="connsiteX8" fmla="*/ 33288 w 490488"/>
              <a:gd name="connsiteY8" fmla="*/ 977900 h 1504950"/>
              <a:gd name="connsiteX9" fmla="*/ 77738 w 490488"/>
              <a:gd name="connsiteY9" fmla="*/ 1117600 h 1504950"/>
              <a:gd name="connsiteX10" fmla="*/ 185688 w 490488"/>
              <a:gd name="connsiteY10" fmla="*/ 1263650 h 1504950"/>
              <a:gd name="connsiteX11" fmla="*/ 268238 w 490488"/>
              <a:gd name="connsiteY11" fmla="*/ 1358900 h 1504950"/>
              <a:gd name="connsiteX12" fmla="*/ 369838 w 490488"/>
              <a:gd name="connsiteY12" fmla="*/ 1447800 h 1504950"/>
              <a:gd name="connsiteX13" fmla="*/ 477788 w 490488"/>
              <a:gd name="connsiteY13" fmla="*/ 1504950 h 15049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490488" h="1504950">
                <a:moveTo>
                  <a:pt x="490488" y="0"/>
                </a:moveTo>
                <a:cubicBezTo>
                  <a:pt x="450271" y="20637"/>
                  <a:pt x="410055" y="41275"/>
                  <a:pt x="369838" y="69850"/>
                </a:cubicBezTo>
                <a:cubicBezTo>
                  <a:pt x="329621" y="98425"/>
                  <a:pt x="284113" y="138642"/>
                  <a:pt x="249188" y="171450"/>
                </a:cubicBezTo>
                <a:cubicBezTo>
                  <a:pt x="214263" y="204258"/>
                  <a:pt x="185688" y="233892"/>
                  <a:pt x="160288" y="266700"/>
                </a:cubicBezTo>
                <a:cubicBezTo>
                  <a:pt x="134888" y="299508"/>
                  <a:pt x="117955" y="328083"/>
                  <a:pt x="96788" y="368300"/>
                </a:cubicBezTo>
                <a:cubicBezTo>
                  <a:pt x="75621" y="408517"/>
                  <a:pt x="48105" y="460375"/>
                  <a:pt x="33288" y="508000"/>
                </a:cubicBezTo>
                <a:cubicBezTo>
                  <a:pt x="18471" y="555625"/>
                  <a:pt x="13180" y="605367"/>
                  <a:pt x="7888" y="654050"/>
                </a:cubicBezTo>
                <a:cubicBezTo>
                  <a:pt x="2596" y="702733"/>
                  <a:pt x="-2695" y="746125"/>
                  <a:pt x="1538" y="800100"/>
                </a:cubicBezTo>
                <a:cubicBezTo>
                  <a:pt x="5771" y="854075"/>
                  <a:pt x="20588" y="924983"/>
                  <a:pt x="33288" y="977900"/>
                </a:cubicBezTo>
                <a:cubicBezTo>
                  <a:pt x="45988" y="1030817"/>
                  <a:pt x="52338" y="1069975"/>
                  <a:pt x="77738" y="1117600"/>
                </a:cubicBezTo>
                <a:cubicBezTo>
                  <a:pt x="103138" y="1165225"/>
                  <a:pt x="153938" y="1223433"/>
                  <a:pt x="185688" y="1263650"/>
                </a:cubicBezTo>
                <a:cubicBezTo>
                  <a:pt x="217438" y="1303867"/>
                  <a:pt x="237546" y="1328208"/>
                  <a:pt x="268238" y="1358900"/>
                </a:cubicBezTo>
                <a:cubicBezTo>
                  <a:pt x="298930" y="1389592"/>
                  <a:pt x="334913" y="1423458"/>
                  <a:pt x="369838" y="1447800"/>
                </a:cubicBezTo>
                <a:cubicBezTo>
                  <a:pt x="404763" y="1472142"/>
                  <a:pt x="441275" y="1488546"/>
                  <a:pt x="477788" y="1504950"/>
                </a:cubicBezTo>
              </a:path>
            </a:pathLst>
          </a:custGeom>
          <a:noFill/>
          <a:ln>
            <a:prstDash val="lgDash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Freeform: Shape 84">
            <a:extLst>
              <a:ext uri="{FF2B5EF4-FFF2-40B4-BE49-F238E27FC236}">
                <a16:creationId xmlns:a16="http://schemas.microsoft.com/office/drawing/2014/main" id="{36CE4507-94CD-4DBD-A01E-203D0828C9AF}"/>
              </a:ext>
            </a:extLst>
          </p:cNvPr>
          <p:cNvSpPr/>
          <p:nvPr/>
        </p:nvSpPr>
        <p:spPr>
          <a:xfrm>
            <a:off x="3086355" y="582694"/>
            <a:ext cx="510998" cy="1517650"/>
          </a:xfrm>
          <a:custGeom>
            <a:avLst/>
            <a:gdLst>
              <a:gd name="connsiteX0" fmla="*/ 12700 w 509881"/>
              <a:gd name="connsiteY0" fmla="*/ 0 h 1517650"/>
              <a:gd name="connsiteX1" fmla="*/ 76200 w 509881"/>
              <a:gd name="connsiteY1" fmla="*/ 31750 h 1517650"/>
              <a:gd name="connsiteX2" fmla="*/ 139700 w 509881"/>
              <a:gd name="connsiteY2" fmla="*/ 63500 h 1517650"/>
              <a:gd name="connsiteX3" fmla="*/ 234950 w 509881"/>
              <a:gd name="connsiteY3" fmla="*/ 139700 h 1517650"/>
              <a:gd name="connsiteX4" fmla="*/ 273050 w 509881"/>
              <a:gd name="connsiteY4" fmla="*/ 171450 h 1517650"/>
              <a:gd name="connsiteX5" fmla="*/ 311150 w 509881"/>
              <a:gd name="connsiteY5" fmla="*/ 215900 h 1517650"/>
              <a:gd name="connsiteX6" fmla="*/ 355600 w 509881"/>
              <a:gd name="connsiteY6" fmla="*/ 273050 h 1517650"/>
              <a:gd name="connsiteX7" fmla="*/ 400050 w 509881"/>
              <a:gd name="connsiteY7" fmla="*/ 342900 h 1517650"/>
              <a:gd name="connsiteX8" fmla="*/ 444500 w 509881"/>
              <a:gd name="connsiteY8" fmla="*/ 425450 h 1517650"/>
              <a:gd name="connsiteX9" fmla="*/ 482600 w 509881"/>
              <a:gd name="connsiteY9" fmla="*/ 539750 h 1517650"/>
              <a:gd name="connsiteX10" fmla="*/ 508000 w 509881"/>
              <a:gd name="connsiteY10" fmla="*/ 641350 h 1517650"/>
              <a:gd name="connsiteX11" fmla="*/ 508000 w 509881"/>
              <a:gd name="connsiteY11" fmla="*/ 730250 h 1517650"/>
              <a:gd name="connsiteX12" fmla="*/ 508000 w 509881"/>
              <a:gd name="connsiteY12" fmla="*/ 793750 h 1517650"/>
              <a:gd name="connsiteX13" fmla="*/ 508000 w 509881"/>
              <a:gd name="connsiteY13" fmla="*/ 844550 h 1517650"/>
              <a:gd name="connsiteX14" fmla="*/ 482600 w 509881"/>
              <a:gd name="connsiteY14" fmla="*/ 971550 h 1517650"/>
              <a:gd name="connsiteX15" fmla="*/ 444500 w 509881"/>
              <a:gd name="connsiteY15" fmla="*/ 1085850 h 1517650"/>
              <a:gd name="connsiteX16" fmla="*/ 400050 w 509881"/>
              <a:gd name="connsiteY16" fmla="*/ 1168400 h 1517650"/>
              <a:gd name="connsiteX17" fmla="*/ 361950 w 509881"/>
              <a:gd name="connsiteY17" fmla="*/ 1219200 h 1517650"/>
              <a:gd name="connsiteX18" fmla="*/ 336550 w 509881"/>
              <a:gd name="connsiteY18" fmla="*/ 1263650 h 1517650"/>
              <a:gd name="connsiteX19" fmla="*/ 279400 w 509881"/>
              <a:gd name="connsiteY19" fmla="*/ 1320800 h 1517650"/>
              <a:gd name="connsiteX20" fmla="*/ 222250 w 509881"/>
              <a:gd name="connsiteY20" fmla="*/ 1377950 h 1517650"/>
              <a:gd name="connsiteX21" fmla="*/ 165100 w 509881"/>
              <a:gd name="connsiteY21" fmla="*/ 1422400 h 1517650"/>
              <a:gd name="connsiteX22" fmla="*/ 127000 w 509881"/>
              <a:gd name="connsiteY22" fmla="*/ 1454150 h 1517650"/>
              <a:gd name="connsiteX23" fmla="*/ 76200 w 509881"/>
              <a:gd name="connsiteY23" fmla="*/ 1485900 h 1517650"/>
              <a:gd name="connsiteX24" fmla="*/ 38100 w 509881"/>
              <a:gd name="connsiteY24" fmla="*/ 1498600 h 1517650"/>
              <a:gd name="connsiteX25" fmla="*/ 0 w 509881"/>
              <a:gd name="connsiteY25" fmla="*/ 1517650 h 15176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</a:cxnLst>
            <a:rect l="l" t="t" r="r" b="b"/>
            <a:pathLst>
              <a:path w="509881" h="1517650">
                <a:moveTo>
                  <a:pt x="12700" y="0"/>
                </a:moveTo>
                <a:lnTo>
                  <a:pt x="76200" y="31750"/>
                </a:lnTo>
                <a:cubicBezTo>
                  <a:pt x="97367" y="42333"/>
                  <a:pt x="113242" y="45508"/>
                  <a:pt x="139700" y="63500"/>
                </a:cubicBezTo>
                <a:cubicBezTo>
                  <a:pt x="166158" y="81492"/>
                  <a:pt x="212725" y="121708"/>
                  <a:pt x="234950" y="139700"/>
                </a:cubicBezTo>
                <a:cubicBezTo>
                  <a:pt x="257175" y="157692"/>
                  <a:pt x="260350" y="158750"/>
                  <a:pt x="273050" y="171450"/>
                </a:cubicBezTo>
                <a:cubicBezTo>
                  <a:pt x="285750" y="184150"/>
                  <a:pt x="297392" y="198967"/>
                  <a:pt x="311150" y="215900"/>
                </a:cubicBezTo>
                <a:cubicBezTo>
                  <a:pt x="324908" y="232833"/>
                  <a:pt x="340783" y="251883"/>
                  <a:pt x="355600" y="273050"/>
                </a:cubicBezTo>
                <a:cubicBezTo>
                  <a:pt x="370417" y="294217"/>
                  <a:pt x="385233" y="317500"/>
                  <a:pt x="400050" y="342900"/>
                </a:cubicBezTo>
                <a:cubicBezTo>
                  <a:pt x="414867" y="368300"/>
                  <a:pt x="430742" y="392642"/>
                  <a:pt x="444500" y="425450"/>
                </a:cubicBezTo>
                <a:cubicBezTo>
                  <a:pt x="458258" y="458258"/>
                  <a:pt x="472017" y="503767"/>
                  <a:pt x="482600" y="539750"/>
                </a:cubicBezTo>
                <a:cubicBezTo>
                  <a:pt x="493183" y="575733"/>
                  <a:pt x="503767" y="609600"/>
                  <a:pt x="508000" y="641350"/>
                </a:cubicBezTo>
                <a:cubicBezTo>
                  <a:pt x="512233" y="673100"/>
                  <a:pt x="508000" y="730250"/>
                  <a:pt x="508000" y="730250"/>
                </a:cubicBezTo>
                <a:lnTo>
                  <a:pt x="508000" y="793750"/>
                </a:lnTo>
                <a:cubicBezTo>
                  <a:pt x="508000" y="812800"/>
                  <a:pt x="512233" y="814917"/>
                  <a:pt x="508000" y="844550"/>
                </a:cubicBezTo>
                <a:cubicBezTo>
                  <a:pt x="503767" y="874183"/>
                  <a:pt x="493183" y="931333"/>
                  <a:pt x="482600" y="971550"/>
                </a:cubicBezTo>
                <a:cubicBezTo>
                  <a:pt x="472017" y="1011767"/>
                  <a:pt x="458258" y="1053042"/>
                  <a:pt x="444500" y="1085850"/>
                </a:cubicBezTo>
                <a:cubicBezTo>
                  <a:pt x="430742" y="1118658"/>
                  <a:pt x="413808" y="1146175"/>
                  <a:pt x="400050" y="1168400"/>
                </a:cubicBezTo>
                <a:cubicBezTo>
                  <a:pt x="386292" y="1190625"/>
                  <a:pt x="372533" y="1203325"/>
                  <a:pt x="361950" y="1219200"/>
                </a:cubicBezTo>
                <a:cubicBezTo>
                  <a:pt x="351367" y="1235075"/>
                  <a:pt x="350308" y="1246717"/>
                  <a:pt x="336550" y="1263650"/>
                </a:cubicBezTo>
                <a:cubicBezTo>
                  <a:pt x="322792" y="1280583"/>
                  <a:pt x="279400" y="1320800"/>
                  <a:pt x="279400" y="1320800"/>
                </a:cubicBezTo>
                <a:cubicBezTo>
                  <a:pt x="260350" y="1339850"/>
                  <a:pt x="241300" y="1361017"/>
                  <a:pt x="222250" y="1377950"/>
                </a:cubicBezTo>
                <a:cubicBezTo>
                  <a:pt x="203200" y="1394883"/>
                  <a:pt x="180975" y="1409700"/>
                  <a:pt x="165100" y="1422400"/>
                </a:cubicBezTo>
                <a:cubicBezTo>
                  <a:pt x="149225" y="1435100"/>
                  <a:pt x="141817" y="1443567"/>
                  <a:pt x="127000" y="1454150"/>
                </a:cubicBezTo>
                <a:cubicBezTo>
                  <a:pt x="112183" y="1464733"/>
                  <a:pt x="91017" y="1478492"/>
                  <a:pt x="76200" y="1485900"/>
                </a:cubicBezTo>
                <a:cubicBezTo>
                  <a:pt x="61383" y="1493308"/>
                  <a:pt x="50800" y="1493308"/>
                  <a:pt x="38100" y="1498600"/>
                </a:cubicBezTo>
                <a:cubicBezTo>
                  <a:pt x="25400" y="1503892"/>
                  <a:pt x="12700" y="1510771"/>
                  <a:pt x="0" y="1517650"/>
                </a:cubicBezTo>
              </a:path>
            </a:pathLst>
          </a:custGeom>
          <a:noFill/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Freeform: Shape 85">
            <a:extLst>
              <a:ext uri="{FF2B5EF4-FFF2-40B4-BE49-F238E27FC236}">
                <a16:creationId xmlns:a16="http://schemas.microsoft.com/office/drawing/2014/main" id="{FE8A68DD-A142-45AC-941D-E5A1962FDA26}"/>
              </a:ext>
            </a:extLst>
          </p:cNvPr>
          <p:cNvSpPr/>
          <p:nvPr/>
        </p:nvSpPr>
        <p:spPr>
          <a:xfrm>
            <a:off x="3061799" y="571581"/>
            <a:ext cx="522796" cy="1531999"/>
          </a:xfrm>
          <a:custGeom>
            <a:avLst/>
            <a:gdLst>
              <a:gd name="connsiteX0" fmla="*/ 12700 w 509881"/>
              <a:gd name="connsiteY0" fmla="*/ 0 h 1517650"/>
              <a:gd name="connsiteX1" fmla="*/ 76200 w 509881"/>
              <a:gd name="connsiteY1" fmla="*/ 31750 h 1517650"/>
              <a:gd name="connsiteX2" fmla="*/ 139700 w 509881"/>
              <a:gd name="connsiteY2" fmla="*/ 63500 h 1517650"/>
              <a:gd name="connsiteX3" fmla="*/ 234950 w 509881"/>
              <a:gd name="connsiteY3" fmla="*/ 139700 h 1517650"/>
              <a:gd name="connsiteX4" fmla="*/ 273050 w 509881"/>
              <a:gd name="connsiteY4" fmla="*/ 171450 h 1517650"/>
              <a:gd name="connsiteX5" fmla="*/ 311150 w 509881"/>
              <a:gd name="connsiteY5" fmla="*/ 215900 h 1517650"/>
              <a:gd name="connsiteX6" fmla="*/ 355600 w 509881"/>
              <a:gd name="connsiteY6" fmla="*/ 273050 h 1517650"/>
              <a:gd name="connsiteX7" fmla="*/ 400050 w 509881"/>
              <a:gd name="connsiteY7" fmla="*/ 342900 h 1517650"/>
              <a:gd name="connsiteX8" fmla="*/ 444500 w 509881"/>
              <a:gd name="connsiteY8" fmla="*/ 425450 h 1517650"/>
              <a:gd name="connsiteX9" fmla="*/ 482600 w 509881"/>
              <a:gd name="connsiteY9" fmla="*/ 539750 h 1517650"/>
              <a:gd name="connsiteX10" fmla="*/ 508000 w 509881"/>
              <a:gd name="connsiteY10" fmla="*/ 641350 h 1517650"/>
              <a:gd name="connsiteX11" fmla="*/ 508000 w 509881"/>
              <a:gd name="connsiteY11" fmla="*/ 730250 h 1517650"/>
              <a:gd name="connsiteX12" fmla="*/ 508000 w 509881"/>
              <a:gd name="connsiteY12" fmla="*/ 793750 h 1517650"/>
              <a:gd name="connsiteX13" fmla="*/ 508000 w 509881"/>
              <a:gd name="connsiteY13" fmla="*/ 844550 h 1517650"/>
              <a:gd name="connsiteX14" fmla="*/ 482600 w 509881"/>
              <a:gd name="connsiteY14" fmla="*/ 971550 h 1517650"/>
              <a:gd name="connsiteX15" fmla="*/ 444500 w 509881"/>
              <a:gd name="connsiteY15" fmla="*/ 1085850 h 1517650"/>
              <a:gd name="connsiteX16" fmla="*/ 400050 w 509881"/>
              <a:gd name="connsiteY16" fmla="*/ 1168400 h 1517650"/>
              <a:gd name="connsiteX17" fmla="*/ 361950 w 509881"/>
              <a:gd name="connsiteY17" fmla="*/ 1219200 h 1517650"/>
              <a:gd name="connsiteX18" fmla="*/ 336550 w 509881"/>
              <a:gd name="connsiteY18" fmla="*/ 1263650 h 1517650"/>
              <a:gd name="connsiteX19" fmla="*/ 279400 w 509881"/>
              <a:gd name="connsiteY19" fmla="*/ 1320800 h 1517650"/>
              <a:gd name="connsiteX20" fmla="*/ 222250 w 509881"/>
              <a:gd name="connsiteY20" fmla="*/ 1377950 h 1517650"/>
              <a:gd name="connsiteX21" fmla="*/ 165100 w 509881"/>
              <a:gd name="connsiteY21" fmla="*/ 1422400 h 1517650"/>
              <a:gd name="connsiteX22" fmla="*/ 127000 w 509881"/>
              <a:gd name="connsiteY22" fmla="*/ 1454150 h 1517650"/>
              <a:gd name="connsiteX23" fmla="*/ 76200 w 509881"/>
              <a:gd name="connsiteY23" fmla="*/ 1485900 h 1517650"/>
              <a:gd name="connsiteX24" fmla="*/ 38100 w 509881"/>
              <a:gd name="connsiteY24" fmla="*/ 1498600 h 1517650"/>
              <a:gd name="connsiteX25" fmla="*/ 0 w 509881"/>
              <a:gd name="connsiteY25" fmla="*/ 1517650 h 15176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</a:cxnLst>
            <a:rect l="l" t="t" r="r" b="b"/>
            <a:pathLst>
              <a:path w="509881" h="1517650">
                <a:moveTo>
                  <a:pt x="12700" y="0"/>
                </a:moveTo>
                <a:lnTo>
                  <a:pt x="76200" y="31750"/>
                </a:lnTo>
                <a:cubicBezTo>
                  <a:pt x="97367" y="42333"/>
                  <a:pt x="113242" y="45508"/>
                  <a:pt x="139700" y="63500"/>
                </a:cubicBezTo>
                <a:cubicBezTo>
                  <a:pt x="166158" y="81492"/>
                  <a:pt x="212725" y="121708"/>
                  <a:pt x="234950" y="139700"/>
                </a:cubicBezTo>
                <a:cubicBezTo>
                  <a:pt x="257175" y="157692"/>
                  <a:pt x="260350" y="158750"/>
                  <a:pt x="273050" y="171450"/>
                </a:cubicBezTo>
                <a:cubicBezTo>
                  <a:pt x="285750" y="184150"/>
                  <a:pt x="297392" y="198967"/>
                  <a:pt x="311150" y="215900"/>
                </a:cubicBezTo>
                <a:cubicBezTo>
                  <a:pt x="324908" y="232833"/>
                  <a:pt x="340783" y="251883"/>
                  <a:pt x="355600" y="273050"/>
                </a:cubicBezTo>
                <a:cubicBezTo>
                  <a:pt x="370417" y="294217"/>
                  <a:pt x="385233" y="317500"/>
                  <a:pt x="400050" y="342900"/>
                </a:cubicBezTo>
                <a:cubicBezTo>
                  <a:pt x="414867" y="368300"/>
                  <a:pt x="430742" y="392642"/>
                  <a:pt x="444500" y="425450"/>
                </a:cubicBezTo>
                <a:cubicBezTo>
                  <a:pt x="458258" y="458258"/>
                  <a:pt x="472017" y="503767"/>
                  <a:pt x="482600" y="539750"/>
                </a:cubicBezTo>
                <a:cubicBezTo>
                  <a:pt x="493183" y="575733"/>
                  <a:pt x="503767" y="609600"/>
                  <a:pt x="508000" y="641350"/>
                </a:cubicBezTo>
                <a:cubicBezTo>
                  <a:pt x="512233" y="673100"/>
                  <a:pt x="508000" y="730250"/>
                  <a:pt x="508000" y="730250"/>
                </a:cubicBezTo>
                <a:lnTo>
                  <a:pt x="508000" y="793750"/>
                </a:lnTo>
                <a:cubicBezTo>
                  <a:pt x="508000" y="812800"/>
                  <a:pt x="512233" y="814917"/>
                  <a:pt x="508000" y="844550"/>
                </a:cubicBezTo>
                <a:cubicBezTo>
                  <a:pt x="503767" y="874183"/>
                  <a:pt x="493183" y="931333"/>
                  <a:pt x="482600" y="971550"/>
                </a:cubicBezTo>
                <a:cubicBezTo>
                  <a:pt x="472017" y="1011767"/>
                  <a:pt x="458258" y="1053042"/>
                  <a:pt x="444500" y="1085850"/>
                </a:cubicBezTo>
                <a:cubicBezTo>
                  <a:pt x="430742" y="1118658"/>
                  <a:pt x="413808" y="1146175"/>
                  <a:pt x="400050" y="1168400"/>
                </a:cubicBezTo>
                <a:cubicBezTo>
                  <a:pt x="386292" y="1190625"/>
                  <a:pt x="372533" y="1203325"/>
                  <a:pt x="361950" y="1219200"/>
                </a:cubicBezTo>
                <a:cubicBezTo>
                  <a:pt x="351367" y="1235075"/>
                  <a:pt x="350308" y="1246717"/>
                  <a:pt x="336550" y="1263650"/>
                </a:cubicBezTo>
                <a:cubicBezTo>
                  <a:pt x="322792" y="1280583"/>
                  <a:pt x="279400" y="1320800"/>
                  <a:pt x="279400" y="1320800"/>
                </a:cubicBezTo>
                <a:cubicBezTo>
                  <a:pt x="260350" y="1339850"/>
                  <a:pt x="241300" y="1361017"/>
                  <a:pt x="222250" y="1377950"/>
                </a:cubicBezTo>
                <a:cubicBezTo>
                  <a:pt x="203200" y="1394883"/>
                  <a:pt x="180975" y="1409700"/>
                  <a:pt x="165100" y="1422400"/>
                </a:cubicBezTo>
                <a:cubicBezTo>
                  <a:pt x="149225" y="1435100"/>
                  <a:pt x="141817" y="1443567"/>
                  <a:pt x="127000" y="1454150"/>
                </a:cubicBezTo>
                <a:cubicBezTo>
                  <a:pt x="112183" y="1464733"/>
                  <a:pt x="91017" y="1478492"/>
                  <a:pt x="76200" y="1485900"/>
                </a:cubicBezTo>
                <a:cubicBezTo>
                  <a:pt x="61383" y="1493308"/>
                  <a:pt x="50800" y="1493308"/>
                  <a:pt x="38100" y="1498600"/>
                </a:cubicBezTo>
                <a:cubicBezTo>
                  <a:pt x="25400" y="1503892"/>
                  <a:pt x="12700" y="1510771"/>
                  <a:pt x="0" y="1517650"/>
                </a:cubicBezTo>
              </a:path>
            </a:pathLst>
          </a:custGeom>
          <a:noFill/>
          <a:ln>
            <a:solidFill>
              <a:srgbClr val="FF0000"/>
            </a:solidFill>
            <a:prstDash val="lgDash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467F5E24-E127-4F00-9F75-4D4509B2EDC9}"/>
              </a:ext>
            </a:extLst>
          </p:cNvPr>
          <p:cNvCxnSpPr/>
          <p:nvPr/>
        </p:nvCxnSpPr>
        <p:spPr>
          <a:xfrm flipV="1">
            <a:off x="4002475" y="1841115"/>
            <a:ext cx="0" cy="140638"/>
          </a:xfrm>
          <a:prstGeom prst="straightConnector1">
            <a:avLst/>
          </a:prstGeom>
          <a:ln>
            <a:solidFill>
              <a:schemeClr val="accent5">
                <a:lumMod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92CDC048-ECF1-4DFF-953D-6A467125C92F}"/>
              </a:ext>
            </a:extLst>
          </p:cNvPr>
          <p:cNvSpPr txBox="1"/>
          <p:nvPr/>
        </p:nvSpPr>
        <p:spPr>
          <a:xfrm>
            <a:off x="3782617" y="1220660"/>
            <a:ext cx="38504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>
                <a:solidFill>
                  <a:srgbClr val="FF0000"/>
                </a:solidFill>
              </a:rPr>
              <a:t>p21</a:t>
            </a:r>
            <a:endParaRPr lang="en-US" sz="1013" baseline="30000" dirty="0">
              <a:solidFill>
                <a:srgbClr val="FF0000"/>
              </a:solidFill>
            </a:endParaRP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93C26E97-0A75-4E49-AB9C-ACF8B3520D42}"/>
              </a:ext>
            </a:extLst>
          </p:cNvPr>
          <p:cNvCxnSpPr/>
          <p:nvPr/>
        </p:nvCxnSpPr>
        <p:spPr>
          <a:xfrm>
            <a:off x="3777603" y="1301816"/>
            <a:ext cx="0" cy="10197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Oval 40">
            <a:extLst>
              <a:ext uri="{FF2B5EF4-FFF2-40B4-BE49-F238E27FC236}">
                <a16:creationId xmlns:a16="http://schemas.microsoft.com/office/drawing/2014/main" id="{EE643195-98BC-42F5-AFC0-3E5B8609C875}"/>
              </a:ext>
            </a:extLst>
          </p:cNvPr>
          <p:cNvSpPr/>
          <p:nvPr/>
        </p:nvSpPr>
        <p:spPr>
          <a:xfrm>
            <a:off x="3119187" y="3114368"/>
            <a:ext cx="84168" cy="87292"/>
          </a:xfrm>
          <a:prstGeom prst="ellipse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51D33E7A-8767-45D0-9E94-F058C66E2684}"/>
              </a:ext>
            </a:extLst>
          </p:cNvPr>
          <p:cNvCxnSpPr>
            <a:cxnSpLocks/>
          </p:cNvCxnSpPr>
          <p:nvPr/>
        </p:nvCxnSpPr>
        <p:spPr>
          <a:xfrm>
            <a:off x="3659687" y="1349636"/>
            <a:ext cx="120507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Oval 41">
            <a:extLst>
              <a:ext uri="{FF2B5EF4-FFF2-40B4-BE49-F238E27FC236}">
                <a16:creationId xmlns:a16="http://schemas.microsoft.com/office/drawing/2014/main" id="{03FCA70F-85A7-4E4C-9070-58E578776F23}"/>
              </a:ext>
            </a:extLst>
          </p:cNvPr>
          <p:cNvSpPr/>
          <p:nvPr/>
        </p:nvSpPr>
        <p:spPr>
          <a:xfrm>
            <a:off x="1795432" y="2948839"/>
            <a:ext cx="91045" cy="95864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9008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</TotalTime>
  <Words>106</Words>
  <Application>Microsoft Macintosh PowerPoint</Application>
  <PresentationFormat>Letter Paper (8.5x11 in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umar, Raj</dc:creator>
  <cp:lastModifiedBy>Kumar, Raj</cp:lastModifiedBy>
  <cp:revision>24</cp:revision>
  <dcterms:created xsi:type="dcterms:W3CDTF">2018-08-13T22:54:38Z</dcterms:created>
  <dcterms:modified xsi:type="dcterms:W3CDTF">2018-12-28T18:23:13Z</dcterms:modified>
</cp:coreProperties>
</file>